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267" r:id="rId3"/>
    <p:sldId id="269" r:id="rId4"/>
  </p:sldIdLst>
  <p:sldSz cx="9601200" cy="12801600" type="A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777" autoAdjust="0"/>
    <p:restoredTop sz="94660"/>
  </p:normalViewPr>
  <p:slideViewPr>
    <p:cSldViewPr snapToGrid="0">
      <p:cViewPr varScale="1">
        <p:scale>
          <a:sx n="52" d="100"/>
          <a:sy n="52" d="100"/>
        </p:scale>
        <p:origin x="257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9389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09019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2813671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4"/>
          </a:xfrm>
        </p:spPr>
        <p:txBody>
          <a:bodyPr anchor="b"/>
          <a:lstStyle>
            <a:lvl1pPr algn="ctr">
              <a:defRPr sz="5815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5"/>
            <a:ext cx="7200900" cy="3090755"/>
          </a:xfrm>
        </p:spPr>
        <p:txBody>
          <a:bodyPr/>
          <a:lstStyle>
            <a:lvl1pPr marL="0" indent="0" algn="ctr">
              <a:buNone/>
              <a:defRPr sz="2326"/>
            </a:lvl1pPr>
            <a:lvl2pPr marL="443130" indent="0" algn="ctr">
              <a:buNone/>
              <a:defRPr sz="1938"/>
            </a:lvl2pPr>
            <a:lvl3pPr marL="886259" indent="0" algn="ctr">
              <a:buNone/>
              <a:defRPr sz="1745"/>
            </a:lvl3pPr>
            <a:lvl4pPr marL="1329389" indent="0" algn="ctr">
              <a:buNone/>
              <a:defRPr sz="1551"/>
            </a:lvl4pPr>
            <a:lvl5pPr marL="1772519" indent="0" algn="ctr">
              <a:buNone/>
              <a:defRPr sz="1551"/>
            </a:lvl5pPr>
            <a:lvl6pPr marL="2215648" indent="0" algn="ctr">
              <a:buNone/>
              <a:defRPr sz="1551"/>
            </a:lvl6pPr>
            <a:lvl7pPr marL="2658778" indent="0" algn="ctr">
              <a:buNone/>
              <a:defRPr sz="1551"/>
            </a:lvl7pPr>
            <a:lvl8pPr marL="3101908" indent="0" algn="ctr">
              <a:buNone/>
              <a:defRPr sz="1551"/>
            </a:lvl8pPr>
            <a:lvl9pPr marL="3545037" indent="0" algn="ctr">
              <a:buNone/>
              <a:defRPr sz="1551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328490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048913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3" y="3191514"/>
            <a:ext cx="8281035" cy="5325109"/>
          </a:xfrm>
        </p:spPr>
        <p:txBody>
          <a:bodyPr anchor="b"/>
          <a:lstStyle>
            <a:lvl1pPr>
              <a:defRPr sz="5815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3" y="8567001"/>
            <a:ext cx="8281035" cy="2800349"/>
          </a:xfrm>
        </p:spPr>
        <p:txBody>
          <a:bodyPr/>
          <a:lstStyle>
            <a:lvl1pPr marL="0" indent="0">
              <a:buNone/>
              <a:defRPr sz="2326">
                <a:solidFill>
                  <a:schemeClr val="tx1"/>
                </a:solidFill>
              </a:defRPr>
            </a:lvl1pPr>
            <a:lvl2pPr marL="443130" indent="0">
              <a:buNone/>
              <a:defRPr sz="1938">
                <a:solidFill>
                  <a:schemeClr val="tx1">
                    <a:tint val="75000"/>
                  </a:schemeClr>
                </a:solidFill>
              </a:defRPr>
            </a:lvl2pPr>
            <a:lvl3pPr marL="886259" indent="0">
              <a:buNone/>
              <a:defRPr sz="1745">
                <a:solidFill>
                  <a:schemeClr val="tx1">
                    <a:tint val="75000"/>
                  </a:schemeClr>
                </a:solidFill>
              </a:defRPr>
            </a:lvl3pPr>
            <a:lvl4pPr marL="1329389" indent="0">
              <a:buNone/>
              <a:defRPr sz="1551">
                <a:solidFill>
                  <a:schemeClr val="tx1">
                    <a:tint val="75000"/>
                  </a:schemeClr>
                </a:solidFill>
              </a:defRPr>
            </a:lvl4pPr>
            <a:lvl5pPr marL="1772519" indent="0">
              <a:buNone/>
              <a:defRPr sz="1551">
                <a:solidFill>
                  <a:schemeClr val="tx1">
                    <a:tint val="75000"/>
                  </a:schemeClr>
                </a:solidFill>
              </a:defRPr>
            </a:lvl5pPr>
            <a:lvl6pPr marL="2215648" indent="0">
              <a:buNone/>
              <a:defRPr sz="1551">
                <a:solidFill>
                  <a:schemeClr val="tx1">
                    <a:tint val="75000"/>
                  </a:schemeClr>
                </a:solidFill>
              </a:defRPr>
            </a:lvl6pPr>
            <a:lvl7pPr marL="2658778" indent="0">
              <a:buNone/>
              <a:defRPr sz="1551">
                <a:solidFill>
                  <a:schemeClr val="tx1">
                    <a:tint val="75000"/>
                  </a:schemeClr>
                </a:solidFill>
              </a:defRPr>
            </a:lvl7pPr>
            <a:lvl8pPr marL="3101908" indent="0">
              <a:buNone/>
              <a:defRPr sz="1551">
                <a:solidFill>
                  <a:schemeClr val="tx1">
                    <a:tint val="75000"/>
                  </a:schemeClr>
                </a:solidFill>
              </a:defRPr>
            </a:lvl8pPr>
            <a:lvl9pPr marL="3545037" indent="0">
              <a:buNone/>
              <a:defRPr sz="155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4062832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6525063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4" y="681570"/>
            <a:ext cx="8281035" cy="2474384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2"/>
            <a:ext cx="4061757" cy="1537969"/>
          </a:xfrm>
        </p:spPr>
        <p:txBody>
          <a:bodyPr anchor="b"/>
          <a:lstStyle>
            <a:lvl1pPr marL="0" indent="0">
              <a:buNone/>
              <a:defRPr sz="2326" b="1"/>
            </a:lvl1pPr>
            <a:lvl2pPr marL="443130" indent="0">
              <a:buNone/>
              <a:defRPr sz="1938" b="1"/>
            </a:lvl2pPr>
            <a:lvl3pPr marL="886259" indent="0">
              <a:buNone/>
              <a:defRPr sz="1745" b="1"/>
            </a:lvl3pPr>
            <a:lvl4pPr marL="1329389" indent="0">
              <a:buNone/>
              <a:defRPr sz="1551" b="1"/>
            </a:lvl4pPr>
            <a:lvl5pPr marL="1772519" indent="0">
              <a:buNone/>
              <a:defRPr sz="1551" b="1"/>
            </a:lvl5pPr>
            <a:lvl6pPr marL="2215648" indent="0">
              <a:buNone/>
              <a:defRPr sz="1551" b="1"/>
            </a:lvl6pPr>
            <a:lvl7pPr marL="2658778" indent="0">
              <a:buNone/>
              <a:defRPr sz="1551" b="1"/>
            </a:lvl7pPr>
            <a:lvl8pPr marL="3101908" indent="0">
              <a:buNone/>
              <a:defRPr sz="1551" b="1"/>
            </a:lvl8pPr>
            <a:lvl9pPr marL="3545037" indent="0">
              <a:buNone/>
              <a:defRPr sz="1551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1"/>
            <a:ext cx="4061757" cy="687789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9" y="3138172"/>
            <a:ext cx="4081760" cy="1537969"/>
          </a:xfrm>
        </p:spPr>
        <p:txBody>
          <a:bodyPr anchor="b"/>
          <a:lstStyle>
            <a:lvl1pPr marL="0" indent="0">
              <a:buNone/>
              <a:defRPr sz="2326" b="1"/>
            </a:lvl1pPr>
            <a:lvl2pPr marL="443130" indent="0">
              <a:buNone/>
              <a:defRPr sz="1938" b="1"/>
            </a:lvl2pPr>
            <a:lvl3pPr marL="886259" indent="0">
              <a:buNone/>
              <a:defRPr sz="1745" b="1"/>
            </a:lvl3pPr>
            <a:lvl4pPr marL="1329389" indent="0">
              <a:buNone/>
              <a:defRPr sz="1551" b="1"/>
            </a:lvl4pPr>
            <a:lvl5pPr marL="1772519" indent="0">
              <a:buNone/>
              <a:defRPr sz="1551" b="1"/>
            </a:lvl5pPr>
            <a:lvl6pPr marL="2215648" indent="0">
              <a:buNone/>
              <a:defRPr sz="1551" b="1"/>
            </a:lvl6pPr>
            <a:lvl7pPr marL="2658778" indent="0">
              <a:buNone/>
              <a:defRPr sz="1551" b="1"/>
            </a:lvl7pPr>
            <a:lvl8pPr marL="3101908" indent="0">
              <a:buNone/>
              <a:defRPr sz="1551" b="1"/>
            </a:lvl8pPr>
            <a:lvl9pPr marL="3545037" indent="0">
              <a:buNone/>
              <a:defRPr sz="1551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9" y="4676141"/>
            <a:ext cx="4081760" cy="687789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1444866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4620139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13487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8" cy="2987040"/>
          </a:xfrm>
        </p:spPr>
        <p:txBody>
          <a:bodyPr anchor="b"/>
          <a:lstStyle>
            <a:lvl1pPr>
              <a:defRPr sz="310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1" y="1843197"/>
            <a:ext cx="4860608" cy="9097434"/>
          </a:xfrm>
        </p:spPr>
        <p:txBody>
          <a:bodyPr/>
          <a:lstStyle>
            <a:lvl1pPr>
              <a:defRPr sz="3102"/>
            </a:lvl1pPr>
            <a:lvl2pPr>
              <a:defRPr sz="2714"/>
            </a:lvl2pPr>
            <a:lvl3pPr>
              <a:defRPr sz="2326"/>
            </a:lvl3pPr>
            <a:lvl4pPr>
              <a:defRPr sz="1938"/>
            </a:lvl4pPr>
            <a:lvl5pPr>
              <a:defRPr sz="1938"/>
            </a:lvl5pPr>
            <a:lvl6pPr>
              <a:defRPr sz="1938"/>
            </a:lvl6pPr>
            <a:lvl7pPr>
              <a:defRPr sz="1938"/>
            </a:lvl7pPr>
            <a:lvl8pPr>
              <a:defRPr sz="1938"/>
            </a:lvl8pPr>
            <a:lvl9pPr>
              <a:defRPr sz="1938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1"/>
            <a:ext cx="3096638" cy="7114964"/>
          </a:xfrm>
        </p:spPr>
        <p:txBody>
          <a:bodyPr/>
          <a:lstStyle>
            <a:lvl1pPr marL="0" indent="0">
              <a:buNone/>
              <a:defRPr sz="1551"/>
            </a:lvl1pPr>
            <a:lvl2pPr marL="443130" indent="0">
              <a:buNone/>
              <a:defRPr sz="1357"/>
            </a:lvl2pPr>
            <a:lvl3pPr marL="886259" indent="0">
              <a:buNone/>
              <a:defRPr sz="1163"/>
            </a:lvl3pPr>
            <a:lvl4pPr marL="1329389" indent="0">
              <a:buNone/>
              <a:defRPr sz="969"/>
            </a:lvl4pPr>
            <a:lvl5pPr marL="1772519" indent="0">
              <a:buNone/>
              <a:defRPr sz="969"/>
            </a:lvl5pPr>
            <a:lvl6pPr marL="2215648" indent="0">
              <a:buNone/>
              <a:defRPr sz="969"/>
            </a:lvl6pPr>
            <a:lvl7pPr marL="2658778" indent="0">
              <a:buNone/>
              <a:defRPr sz="969"/>
            </a:lvl7pPr>
            <a:lvl8pPr marL="3101908" indent="0">
              <a:buNone/>
              <a:defRPr sz="969"/>
            </a:lvl8pPr>
            <a:lvl9pPr marL="3545037" indent="0">
              <a:buNone/>
              <a:defRPr sz="969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9847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7732895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8" cy="2987040"/>
          </a:xfrm>
        </p:spPr>
        <p:txBody>
          <a:bodyPr anchor="b"/>
          <a:lstStyle>
            <a:lvl1pPr>
              <a:defRPr sz="310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1" y="1843197"/>
            <a:ext cx="4860608" cy="9097434"/>
          </a:xfrm>
        </p:spPr>
        <p:txBody>
          <a:bodyPr anchor="t"/>
          <a:lstStyle>
            <a:lvl1pPr marL="0" indent="0">
              <a:buNone/>
              <a:defRPr sz="3102"/>
            </a:lvl1pPr>
            <a:lvl2pPr marL="443130" indent="0">
              <a:buNone/>
              <a:defRPr sz="2714"/>
            </a:lvl2pPr>
            <a:lvl3pPr marL="886259" indent="0">
              <a:buNone/>
              <a:defRPr sz="2326"/>
            </a:lvl3pPr>
            <a:lvl4pPr marL="1329389" indent="0">
              <a:buNone/>
              <a:defRPr sz="1938"/>
            </a:lvl4pPr>
            <a:lvl5pPr marL="1772519" indent="0">
              <a:buNone/>
              <a:defRPr sz="1938"/>
            </a:lvl5pPr>
            <a:lvl6pPr marL="2215648" indent="0">
              <a:buNone/>
              <a:defRPr sz="1938"/>
            </a:lvl6pPr>
            <a:lvl7pPr marL="2658778" indent="0">
              <a:buNone/>
              <a:defRPr sz="1938"/>
            </a:lvl7pPr>
            <a:lvl8pPr marL="3101908" indent="0">
              <a:buNone/>
              <a:defRPr sz="1938"/>
            </a:lvl8pPr>
            <a:lvl9pPr marL="3545037" indent="0">
              <a:buNone/>
              <a:defRPr sz="1938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1"/>
            <a:ext cx="3096638" cy="7114964"/>
          </a:xfrm>
        </p:spPr>
        <p:txBody>
          <a:bodyPr/>
          <a:lstStyle>
            <a:lvl1pPr marL="0" indent="0">
              <a:buNone/>
              <a:defRPr sz="1551"/>
            </a:lvl1pPr>
            <a:lvl2pPr marL="443130" indent="0">
              <a:buNone/>
              <a:defRPr sz="1357"/>
            </a:lvl2pPr>
            <a:lvl3pPr marL="886259" indent="0">
              <a:buNone/>
              <a:defRPr sz="1163"/>
            </a:lvl3pPr>
            <a:lvl4pPr marL="1329389" indent="0">
              <a:buNone/>
              <a:defRPr sz="969"/>
            </a:lvl4pPr>
            <a:lvl5pPr marL="1772519" indent="0">
              <a:buNone/>
              <a:defRPr sz="969"/>
            </a:lvl5pPr>
            <a:lvl6pPr marL="2215648" indent="0">
              <a:buNone/>
              <a:defRPr sz="969"/>
            </a:lvl6pPr>
            <a:lvl7pPr marL="2658778" indent="0">
              <a:buNone/>
              <a:defRPr sz="969"/>
            </a:lvl7pPr>
            <a:lvl8pPr marL="3101908" indent="0">
              <a:buNone/>
              <a:defRPr sz="969"/>
            </a:lvl8pPr>
            <a:lvl9pPr marL="3545037" indent="0">
              <a:buNone/>
              <a:defRPr sz="969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8821957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2449582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60" y="681568"/>
            <a:ext cx="2070258" cy="10848764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8"/>
            <a:ext cx="6090762" cy="10848764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91450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80826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37742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53621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3659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791346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61136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26578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832B8-25FD-4C2C-BA38-566643824BCF}" type="datetimeFigureOut">
              <a:rPr lang="zh-TW" altLang="en-US" smtClean="0"/>
              <a:t>2022/9/2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1BF2D-0004-40D4-843A-A7709F0B1FE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698743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4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4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91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6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801A16-70CF-494E-9268-A809103474F8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2/9/2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9" y="11865191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6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91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6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0D01E2-AB34-4997-950A-4E3D4FAC9762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025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86259" rtl="0" eaLnBrk="1" latinLnBrk="0" hangingPunct="1">
        <a:lnSpc>
          <a:spcPct val="90000"/>
        </a:lnSpc>
        <a:spcBef>
          <a:spcPct val="0"/>
        </a:spcBef>
        <a:buNone/>
        <a:defRPr sz="42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1565" indent="-221565" algn="l" defTabSz="886259" rtl="0" eaLnBrk="1" latinLnBrk="0" hangingPunct="1">
        <a:lnSpc>
          <a:spcPct val="90000"/>
        </a:lnSpc>
        <a:spcBef>
          <a:spcPts val="969"/>
        </a:spcBef>
        <a:buFont typeface="Arial" panose="020B0604020202020204" pitchFamily="34" charset="0"/>
        <a:buChar char="•"/>
        <a:defRPr sz="2714" kern="1200">
          <a:solidFill>
            <a:schemeClr val="tx1"/>
          </a:solidFill>
          <a:latin typeface="+mn-lt"/>
          <a:ea typeface="+mn-ea"/>
          <a:cs typeface="+mn-cs"/>
        </a:defRPr>
      </a:lvl1pPr>
      <a:lvl2pPr marL="664695" indent="-221565" algn="l" defTabSz="886259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2326" kern="1200">
          <a:solidFill>
            <a:schemeClr val="tx1"/>
          </a:solidFill>
          <a:latin typeface="+mn-lt"/>
          <a:ea typeface="+mn-ea"/>
          <a:cs typeface="+mn-cs"/>
        </a:defRPr>
      </a:lvl2pPr>
      <a:lvl3pPr marL="1107824" indent="-221565" algn="l" defTabSz="886259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938" kern="1200">
          <a:solidFill>
            <a:schemeClr val="tx1"/>
          </a:solidFill>
          <a:latin typeface="+mn-lt"/>
          <a:ea typeface="+mn-ea"/>
          <a:cs typeface="+mn-cs"/>
        </a:defRPr>
      </a:lvl3pPr>
      <a:lvl4pPr marL="1550954" indent="-221565" algn="l" defTabSz="886259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45" kern="1200">
          <a:solidFill>
            <a:schemeClr val="tx1"/>
          </a:solidFill>
          <a:latin typeface="+mn-lt"/>
          <a:ea typeface="+mn-ea"/>
          <a:cs typeface="+mn-cs"/>
        </a:defRPr>
      </a:lvl4pPr>
      <a:lvl5pPr marL="1994084" indent="-221565" algn="l" defTabSz="886259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45" kern="1200">
          <a:solidFill>
            <a:schemeClr val="tx1"/>
          </a:solidFill>
          <a:latin typeface="+mn-lt"/>
          <a:ea typeface="+mn-ea"/>
          <a:cs typeface="+mn-cs"/>
        </a:defRPr>
      </a:lvl5pPr>
      <a:lvl6pPr marL="2437213" indent="-221565" algn="l" defTabSz="886259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45" kern="1200">
          <a:solidFill>
            <a:schemeClr val="tx1"/>
          </a:solidFill>
          <a:latin typeface="+mn-lt"/>
          <a:ea typeface="+mn-ea"/>
          <a:cs typeface="+mn-cs"/>
        </a:defRPr>
      </a:lvl6pPr>
      <a:lvl7pPr marL="2880343" indent="-221565" algn="l" defTabSz="886259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45" kern="1200">
          <a:solidFill>
            <a:schemeClr val="tx1"/>
          </a:solidFill>
          <a:latin typeface="+mn-lt"/>
          <a:ea typeface="+mn-ea"/>
          <a:cs typeface="+mn-cs"/>
        </a:defRPr>
      </a:lvl7pPr>
      <a:lvl8pPr marL="3323473" indent="-221565" algn="l" defTabSz="886259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45" kern="1200">
          <a:solidFill>
            <a:schemeClr val="tx1"/>
          </a:solidFill>
          <a:latin typeface="+mn-lt"/>
          <a:ea typeface="+mn-ea"/>
          <a:cs typeface="+mn-cs"/>
        </a:defRPr>
      </a:lvl8pPr>
      <a:lvl9pPr marL="3766602" indent="-221565" algn="l" defTabSz="886259" rtl="0" eaLnBrk="1" latinLnBrk="0" hangingPunct="1">
        <a:lnSpc>
          <a:spcPct val="90000"/>
        </a:lnSpc>
        <a:spcBef>
          <a:spcPts val="485"/>
        </a:spcBef>
        <a:buFont typeface="Arial" panose="020B0604020202020204" pitchFamily="34" charset="0"/>
        <a:buChar char="•"/>
        <a:defRPr sz="17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86259" rtl="0" eaLnBrk="1" latinLnBrk="0" hangingPunct="1">
        <a:defRPr sz="1745" kern="1200">
          <a:solidFill>
            <a:schemeClr val="tx1"/>
          </a:solidFill>
          <a:latin typeface="+mn-lt"/>
          <a:ea typeface="+mn-ea"/>
          <a:cs typeface="+mn-cs"/>
        </a:defRPr>
      </a:lvl1pPr>
      <a:lvl2pPr marL="443130" algn="l" defTabSz="886259" rtl="0" eaLnBrk="1" latinLnBrk="0" hangingPunct="1">
        <a:defRPr sz="1745" kern="1200">
          <a:solidFill>
            <a:schemeClr val="tx1"/>
          </a:solidFill>
          <a:latin typeface="+mn-lt"/>
          <a:ea typeface="+mn-ea"/>
          <a:cs typeface="+mn-cs"/>
        </a:defRPr>
      </a:lvl2pPr>
      <a:lvl3pPr marL="886259" algn="l" defTabSz="886259" rtl="0" eaLnBrk="1" latinLnBrk="0" hangingPunct="1">
        <a:defRPr sz="1745" kern="1200">
          <a:solidFill>
            <a:schemeClr val="tx1"/>
          </a:solidFill>
          <a:latin typeface="+mn-lt"/>
          <a:ea typeface="+mn-ea"/>
          <a:cs typeface="+mn-cs"/>
        </a:defRPr>
      </a:lvl3pPr>
      <a:lvl4pPr marL="1329389" algn="l" defTabSz="886259" rtl="0" eaLnBrk="1" latinLnBrk="0" hangingPunct="1">
        <a:defRPr sz="1745" kern="1200">
          <a:solidFill>
            <a:schemeClr val="tx1"/>
          </a:solidFill>
          <a:latin typeface="+mn-lt"/>
          <a:ea typeface="+mn-ea"/>
          <a:cs typeface="+mn-cs"/>
        </a:defRPr>
      </a:lvl4pPr>
      <a:lvl5pPr marL="1772519" algn="l" defTabSz="886259" rtl="0" eaLnBrk="1" latinLnBrk="0" hangingPunct="1">
        <a:defRPr sz="1745" kern="1200">
          <a:solidFill>
            <a:schemeClr val="tx1"/>
          </a:solidFill>
          <a:latin typeface="+mn-lt"/>
          <a:ea typeface="+mn-ea"/>
          <a:cs typeface="+mn-cs"/>
        </a:defRPr>
      </a:lvl5pPr>
      <a:lvl6pPr marL="2215648" algn="l" defTabSz="886259" rtl="0" eaLnBrk="1" latinLnBrk="0" hangingPunct="1">
        <a:defRPr sz="1745" kern="1200">
          <a:solidFill>
            <a:schemeClr val="tx1"/>
          </a:solidFill>
          <a:latin typeface="+mn-lt"/>
          <a:ea typeface="+mn-ea"/>
          <a:cs typeface="+mn-cs"/>
        </a:defRPr>
      </a:lvl6pPr>
      <a:lvl7pPr marL="2658778" algn="l" defTabSz="886259" rtl="0" eaLnBrk="1" latinLnBrk="0" hangingPunct="1">
        <a:defRPr sz="1745" kern="1200">
          <a:solidFill>
            <a:schemeClr val="tx1"/>
          </a:solidFill>
          <a:latin typeface="+mn-lt"/>
          <a:ea typeface="+mn-ea"/>
          <a:cs typeface="+mn-cs"/>
        </a:defRPr>
      </a:lvl7pPr>
      <a:lvl8pPr marL="3101908" algn="l" defTabSz="886259" rtl="0" eaLnBrk="1" latinLnBrk="0" hangingPunct="1">
        <a:defRPr sz="1745" kern="1200">
          <a:solidFill>
            <a:schemeClr val="tx1"/>
          </a:solidFill>
          <a:latin typeface="+mn-lt"/>
          <a:ea typeface="+mn-ea"/>
          <a:cs typeface="+mn-cs"/>
        </a:defRPr>
      </a:lvl8pPr>
      <a:lvl9pPr marL="3545037" algn="l" defTabSz="886259" rtl="0" eaLnBrk="1" latinLnBrk="0" hangingPunct="1">
        <a:defRPr sz="17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字方塊 5">
            <a:extLst>
              <a:ext uri="{FF2B5EF4-FFF2-40B4-BE49-F238E27FC236}">
                <a16:creationId xmlns:a16="http://schemas.microsoft.com/office/drawing/2014/main" id="{3821C50B-4C87-4E01-8650-386721623277}"/>
              </a:ext>
            </a:extLst>
          </p:cNvPr>
          <p:cNvSpPr txBox="1"/>
          <p:nvPr/>
        </p:nvSpPr>
        <p:spPr>
          <a:xfrm>
            <a:off x="613405" y="5878376"/>
            <a:ext cx="8374390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TW" sz="1400" b="1" kern="1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upplemental Figure S</a:t>
            </a:r>
            <a:r>
              <a:rPr lang="en-US" altLang="zh-TW" sz="1400" b="1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</a:t>
            </a:r>
            <a:r>
              <a:rPr lang="en-US" altLang="zh-TW" sz="1400" b="1" kern="1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.</a:t>
            </a:r>
            <a:endParaRPr lang="zh-TW" altLang="zh-TW" sz="1400" kern="100" dirty="0">
              <a:effectLst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TW" sz="1400" kern="1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The detection limit of L858R, exon 19 deletions and T790M assays. The serially diluted positive reference materials with different variant allele frequencies (VAFs) including 50%, 25%, 10%, 5%, 2.5%, 1%, 0.5%, 0.25%, 0.1% were subjected to ddPCR assays in triplicates at each concentration. The fractional abundance (FA; %) of each dilution points</a:t>
            </a:r>
            <a:r>
              <a:rPr lang="en-US" altLang="zh-TW" sz="14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were calculated by QuantaSoft</a:t>
            </a:r>
            <a:r>
              <a:rPr lang="en-US" altLang="zh-TW" sz="1400" kern="100" baseline="300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TM</a:t>
            </a:r>
            <a:r>
              <a:rPr lang="en-US" altLang="zh-TW" sz="1400" kern="100" dirty="0"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. The observed FA% was shown at y-axis, while the expected VAF% was shown at x-axis.</a:t>
            </a:r>
            <a:r>
              <a:rPr lang="en-US" altLang="zh-TW" sz="14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breviation: E19D, exon 19 deletions.</a:t>
            </a:r>
            <a:endParaRPr lang="en-US" altLang="zh-TW" sz="1400" kern="100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644311CF-D5B7-425A-BA0A-37847DE7BC6C}"/>
              </a:ext>
            </a:extLst>
          </p:cNvPr>
          <p:cNvSpPr txBox="1"/>
          <p:nvPr/>
        </p:nvSpPr>
        <p:spPr>
          <a:xfrm>
            <a:off x="183302" y="110359"/>
            <a:ext cx="42957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  <a:endParaRPr lang="zh-TW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圖片 1">
            <a:extLst>
              <a:ext uri="{FF2B5EF4-FFF2-40B4-BE49-F238E27FC236}">
                <a16:creationId xmlns:a16="http://schemas.microsoft.com/office/drawing/2014/main" id="{B23BE04E-8FF0-4172-8090-C3F4D26082A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6170"/>
          <a:stretch/>
        </p:blipFill>
        <p:spPr>
          <a:xfrm>
            <a:off x="413085" y="892587"/>
            <a:ext cx="8775031" cy="4738192"/>
          </a:xfrm>
          <a:prstGeom prst="rect">
            <a:avLst/>
          </a:prstGeom>
        </p:spPr>
      </p:pic>
      <p:sp>
        <p:nvSpPr>
          <p:cNvPr id="5" name="文字方塊 4">
            <a:extLst>
              <a:ext uri="{FF2B5EF4-FFF2-40B4-BE49-F238E27FC236}">
                <a16:creationId xmlns:a16="http://schemas.microsoft.com/office/drawing/2014/main" id="{758CEA30-8AB6-4948-AC3D-CC569CF84C23}"/>
              </a:ext>
            </a:extLst>
          </p:cNvPr>
          <p:cNvSpPr txBox="1"/>
          <p:nvPr/>
        </p:nvSpPr>
        <p:spPr>
          <a:xfrm>
            <a:off x="5193038" y="2136515"/>
            <a:ext cx="11268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R</a:t>
            </a:r>
            <a:r>
              <a:rPr lang="en-US" altLang="zh-TW" sz="1600" baseline="300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2 </a:t>
            </a:r>
            <a:r>
              <a:rPr lang="en-US" altLang="zh-TW" sz="1600" dirty="0">
                <a:latin typeface="Arial Unicode MS" panose="020B0604020202020204" pitchFamily="34" charset="-120"/>
                <a:ea typeface="Arial Unicode MS" panose="020B0604020202020204" pitchFamily="34" charset="-120"/>
                <a:cs typeface="Arial Unicode MS" panose="020B0604020202020204" pitchFamily="34" charset="-120"/>
              </a:rPr>
              <a:t>&gt;0.99</a:t>
            </a:r>
            <a:endParaRPr lang="zh-TW" altLang="en-US" sz="1600" dirty="0">
              <a:latin typeface="Arial Unicode MS" panose="020B0604020202020204" pitchFamily="34" charset="-120"/>
              <a:ea typeface="Arial Unicode MS" panose="020B0604020202020204" pitchFamily="34" charset="-120"/>
              <a:cs typeface="Arial Unicode MS" panose="020B0604020202020204" pitchFamily="34" charset="-120"/>
            </a:endParaRPr>
          </a:p>
        </p:txBody>
      </p:sp>
    </p:spTree>
    <p:extLst>
      <p:ext uri="{BB962C8B-B14F-4D97-AF65-F5344CB8AC3E}">
        <p14:creationId xmlns:p14="http://schemas.microsoft.com/office/powerpoint/2010/main" val="24091746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群組 1"/>
          <p:cNvGrpSpPr/>
          <p:nvPr/>
        </p:nvGrpSpPr>
        <p:grpSpPr>
          <a:xfrm>
            <a:off x="1677110" y="4429960"/>
            <a:ext cx="6246981" cy="709394"/>
            <a:chOff x="1676581" y="4429960"/>
            <a:chExt cx="6246981" cy="709394"/>
          </a:xfrm>
        </p:grpSpPr>
        <p:cxnSp>
          <p:nvCxnSpPr>
            <p:cNvPr id="5" name="直線接點 4"/>
            <p:cNvCxnSpPr/>
            <p:nvPr/>
          </p:nvCxnSpPr>
          <p:spPr>
            <a:xfrm>
              <a:off x="1676581" y="4429960"/>
              <a:ext cx="146547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" name="文字方塊 8"/>
            <p:cNvSpPr txBox="1"/>
            <p:nvPr/>
          </p:nvSpPr>
          <p:spPr>
            <a:xfrm>
              <a:off x="1768173" y="4450511"/>
              <a:ext cx="1282292" cy="4900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92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ssue</a:t>
              </a:r>
            </a:p>
            <a:p>
              <a:pPr algn="ctr"/>
              <a:r>
                <a:rPr lang="en-US" altLang="zh-TW" sz="1292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(baseline)</a:t>
              </a:r>
              <a:endParaRPr lang="zh-TW" altLang="en-US" sz="1292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直線接點 9"/>
            <p:cNvCxnSpPr/>
            <p:nvPr/>
          </p:nvCxnSpPr>
          <p:spPr>
            <a:xfrm>
              <a:off x="3248261" y="4429960"/>
              <a:ext cx="146547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文字方塊 10"/>
            <p:cNvSpPr txBox="1"/>
            <p:nvPr/>
          </p:nvSpPr>
          <p:spPr>
            <a:xfrm>
              <a:off x="3339853" y="4450511"/>
              <a:ext cx="1282292" cy="4900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92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lasma </a:t>
              </a:r>
            </a:p>
            <a:p>
              <a:pPr algn="ctr"/>
              <a:r>
                <a:rPr lang="en-US" altLang="zh-TW" sz="1292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baseline)</a:t>
              </a:r>
              <a:endParaRPr lang="zh-TW" altLang="en-US" sz="1292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線接點 11"/>
            <p:cNvCxnSpPr/>
            <p:nvPr/>
          </p:nvCxnSpPr>
          <p:spPr>
            <a:xfrm>
              <a:off x="6458085" y="4429960"/>
              <a:ext cx="146547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文字方塊 12"/>
            <p:cNvSpPr txBox="1"/>
            <p:nvPr/>
          </p:nvSpPr>
          <p:spPr>
            <a:xfrm>
              <a:off x="6549677" y="4450511"/>
              <a:ext cx="1308462" cy="4900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92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lasma (Progression)</a:t>
              </a:r>
              <a:endParaRPr lang="zh-TW" altLang="en-US" sz="1292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線接點 13"/>
            <p:cNvCxnSpPr/>
            <p:nvPr/>
          </p:nvCxnSpPr>
          <p:spPr>
            <a:xfrm>
              <a:off x="4853172" y="4429960"/>
              <a:ext cx="146547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文字方塊 14"/>
            <p:cNvSpPr txBox="1"/>
            <p:nvPr/>
          </p:nvSpPr>
          <p:spPr>
            <a:xfrm>
              <a:off x="4944765" y="4450511"/>
              <a:ext cx="1282292" cy="6888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92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mor rebiopsy (Progression)</a:t>
              </a:r>
              <a:endParaRPr lang="zh-TW" altLang="en-US" sz="1292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矩形 16"/>
          <p:cNvSpPr/>
          <p:nvPr/>
        </p:nvSpPr>
        <p:spPr>
          <a:xfrm>
            <a:off x="506601" y="6548265"/>
            <a:ext cx="8587999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TW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zh-TW" sz="1400" b="1" kern="10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zh-TW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TW" altLang="zh-TW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TW" sz="1400" dirty="0">
                <a:latin typeface="Times New Roman" panose="02020603050405020304" pitchFamily="18" charset="0"/>
                <a:ea typeface="Yu Gothic" panose="020B0400000000000000" pitchFamily="34" charset="-128"/>
              </a:rPr>
              <a:t>The distribution of fractional abundance (FA)</a:t>
            </a:r>
            <a:r>
              <a:rPr lang="en-US" altLang="zh-TW" sz="1400" dirty="0">
                <a:latin typeface="Avenir Next LT Pro Light"/>
                <a:ea typeface="Yu Gothic" panose="020B0400000000000000" pitchFamily="34" charset="-128"/>
                <a:cs typeface="Times New Roman" panose="02020603050405020304" pitchFamily="18" charset="0"/>
              </a:rPr>
              <a:t> </a:t>
            </a:r>
            <a:r>
              <a:rPr lang="en-US" altLang="zh-TW" sz="1400" dirty="0">
                <a:latin typeface="Times New Roman" panose="02020603050405020304" pitchFamily="18" charset="0"/>
                <a:ea typeface="Yu Gothic" panose="020B0400000000000000" pitchFamily="34" charset="-128"/>
              </a:rPr>
              <a:t>of </a:t>
            </a:r>
            <a:r>
              <a:rPr lang="en-US" altLang="zh-TW" sz="1400" i="1" dirty="0">
                <a:latin typeface="Times New Roman" panose="02020603050405020304" pitchFamily="18" charset="0"/>
                <a:ea typeface="Yu Gothic" panose="020B0400000000000000" pitchFamily="34" charset="-128"/>
              </a:rPr>
              <a:t>EGFR</a:t>
            </a:r>
            <a:r>
              <a:rPr lang="en-US" altLang="zh-TW" sz="1400" dirty="0">
                <a:latin typeface="Times New Roman" panose="02020603050405020304" pitchFamily="18" charset="0"/>
                <a:ea typeface="Yu Gothic" panose="020B0400000000000000" pitchFamily="34" charset="-128"/>
              </a:rPr>
              <a:t> activating and T790M mutations detected using </a:t>
            </a:r>
            <a:r>
              <a:rPr lang="en-US" altLang="zh-TW" sz="1400" dirty="0" err="1">
                <a:latin typeface="Times New Roman" panose="02020603050405020304" pitchFamily="18" charset="0"/>
                <a:ea typeface="Yu Gothic" panose="020B0400000000000000" pitchFamily="34" charset="-128"/>
              </a:rPr>
              <a:t>ddPCR</a:t>
            </a:r>
            <a:r>
              <a:rPr lang="en-US" altLang="zh-TW" sz="1400" dirty="0">
                <a:latin typeface="Times New Roman" panose="02020603050405020304" pitchFamily="18" charset="0"/>
                <a:ea typeface="Yu Gothic" panose="020B0400000000000000" pitchFamily="34" charset="-128"/>
              </a:rPr>
              <a:t> from plasma and tumor tissues at baseline and disease progression. </a:t>
            </a:r>
            <a:r>
              <a:rPr lang="en-US" altLang="zh-TW" sz="1200" dirty="0">
                <a:latin typeface="Times New Roman" panose="02020603050405020304" pitchFamily="18" charset="0"/>
              </a:rPr>
              <a:t>*</a:t>
            </a:r>
            <a:r>
              <a:rPr lang="en-US" altLang="zh-TW" sz="1200" i="1" dirty="0">
                <a:latin typeface="Times New Roman" panose="02020603050405020304" pitchFamily="18" charset="0"/>
              </a:rPr>
              <a:t>P</a:t>
            </a:r>
            <a:r>
              <a:rPr lang="en-US" altLang="zh-TW" sz="1200" dirty="0">
                <a:latin typeface="Times New Roman" panose="02020603050405020304" pitchFamily="18" charset="0"/>
              </a:rPr>
              <a:t> &lt; </a:t>
            </a:r>
            <a:r>
              <a:rPr lang="en-US" altLang="zh-TW" sz="1200" dirty="0">
                <a:solidFill>
                  <a:srgbClr val="0000FF"/>
                </a:solidFill>
                <a:latin typeface="Times New Roman" panose="02020603050405020304" pitchFamily="18" charset="0"/>
              </a:rPr>
              <a:t>0.</a:t>
            </a:r>
            <a:r>
              <a:rPr lang="en-US" altLang="zh-TW" sz="1200" dirty="0">
                <a:latin typeface="Times New Roman" panose="02020603050405020304" pitchFamily="18" charset="0"/>
              </a:rPr>
              <a:t>05, </a:t>
            </a:r>
            <a:r>
              <a:rPr lang="en-US" altLang="zh-TW" sz="1400" dirty="0">
                <a:latin typeface="Times New Roman" panose="02020603050405020304" pitchFamily="18" charset="0"/>
              </a:rPr>
              <a:t>indicating significant.</a:t>
            </a:r>
            <a:endParaRPr lang="en-US" altLang="zh-TW" sz="14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E331C9EE-9860-4800-A8DB-5884FB3DDBEB}"/>
              </a:ext>
            </a:extLst>
          </p:cNvPr>
          <p:cNvSpPr txBox="1"/>
          <p:nvPr/>
        </p:nvSpPr>
        <p:spPr>
          <a:xfrm>
            <a:off x="183302" y="110359"/>
            <a:ext cx="42957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  <a:endParaRPr lang="zh-TW" altLang="en-US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圖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9332" y="912601"/>
            <a:ext cx="7742537" cy="35679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59893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>
        <p:cut/>
      </p:transition>
    </mc:Choice>
    <mc:Fallback xmlns="">
      <p:transition spd="slow">
        <p:cut/>
      </p:transition>
    </mc:Fallback>
  </mc:AlternateContent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04</TotalTime>
  <Words>171</Words>
  <Application>Microsoft Office PowerPoint</Application>
  <PresentationFormat>A3 Paper (297x420 mm)</PresentationFormat>
  <Paragraphs>1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10" baseType="lpstr">
      <vt:lpstr>Arial Unicode MS</vt:lpstr>
      <vt:lpstr>Arial</vt:lpstr>
      <vt:lpstr>Avenir Next LT Pro Light</vt:lpstr>
      <vt:lpstr>Calibri</vt:lpstr>
      <vt:lpstr>Calibri Light</vt:lpstr>
      <vt:lpstr>Times New Roman</vt:lpstr>
      <vt:lpstr>Office 佈景主題</vt:lpstr>
      <vt:lpstr>1_Office 佈景主題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MDPI-48</cp:lastModifiedBy>
  <cp:revision>61</cp:revision>
  <dcterms:created xsi:type="dcterms:W3CDTF">2021-12-09T02:10:14Z</dcterms:created>
  <dcterms:modified xsi:type="dcterms:W3CDTF">2022-09-26T12:33:33Z</dcterms:modified>
</cp:coreProperties>
</file>